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296F8-A9F0-48DA-9072-EEEFA27AF8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2A1ED-99B0-43F8-B08D-E4D74D8902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C7EB2-8DC7-4766-B583-8CEC264475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F5075-F168-457D-80C3-FA344AD4F4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13B10-D6D9-4A79-B8BC-DB84E3911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12C65-2340-45FD-B6AF-2446A9D7A9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5F06B-C9EF-43D4-BBAF-C914E937B3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850CCF-483A-40DD-8D90-6A1E65596F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8B4AF-7F69-4B17-AF03-3568C6C0DE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EFDB2-422C-4BAF-815F-E710918197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0F74E-BA81-4165-B9A7-86939D9E5A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6E774-39C1-44D9-AA1E-4CEA340AE1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67BA4A-E9E1-4DA9-941E-FA55B2A92DA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8840" y="540720"/>
            <a:ext cx="57880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dditional file 7 (AF7_gene bank_breeding_field.ppt): Heatmap of Z-score normalized thousand grain weight (TGW) data from drought stress experiments of field-grown (F), rain shelter (RS) from the two consecutive years (2007 and 2008). Red colour indicates higher TGW, yellow –medium and blue -lower TGW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832120" y="1468440"/>
            <a:ext cx="1143000" cy="5184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07:39:06Z</dcterms:created>
  <dc:creator>srinivas</dc:creator>
  <dc:description/>
  <dc:language>en-US</dc:language>
  <cp:lastModifiedBy>srinivas</cp:lastModifiedBy>
  <dcterms:modified xsi:type="dcterms:W3CDTF">2010-11-23T15:45:17Z</dcterms:modified>
  <cp:revision>12</cp:revision>
  <dc:subject/>
  <dc:title>Slide 1</dc:title>
</cp:coreProperties>
</file>